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60" r:id="rId1"/>
  </p:sldMasterIdLst>
  <p:notesMasterIdLst>
    <p:notesMasterId r:id="rId3"/>
  </p:notesMasterIdLst>
  <p:sldIdLst>
    <p:sldId id="266" r:id="rId2"/>
  </p:sldIdLst>
  <p:sldSz cx="6858000" cy="9906000" type="A4"/>
  <p:notesSz cx="6858000" cy="9144000"/>
  <p:defaultTextStyle>
    <a:defPPr>
      <a:defRPr lang="fa-IR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B6565"/>
    <a:srgbClr val="D87272"/>
    <a:srgbClr val="D1D167"/>
    <a:srgbClr val="8ECC8E"/>
    <a:srgbClr val="CBCB65"/>
    <a:srgbClr val="9CDA9C"/>
    <a:srgbClr val="A0DEA0"/>
    <a:srgbClr val="6F6FD5"/>
    <a:srgbClr val="8989EF"/>
    <a:srgbClr val="EA848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380"/>
    <p:restoredTop sz="94660"/>
  </p:normalViewPr>
  <p:slideViewPr>
    <p:cSldViewPr snapToGrid="0">
      <p:cViewPr>
        <p:scale>
          <a:sx n="90" d="100"/>
          <a:sy n="90" d="100"/>
        </p:scale>
        <p:origin x="1882" y="-16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CA984855-599D-4309-85ED-7EAE5690764B}" type="datetimeFigureOut">
              <a:rPr lang="fa-IR" smtClean="0"/>
              <a:t>02/02/1444</a:t>
            </a:fld>
            <a:endParaRPr lang="fa-I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fa-I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F0B5A1A4-4AC8-4DFF-9D93-060A18A138CB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2011030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25571-EC6A-4930-BA58-3890F7A8C3ED}" type="datetimeFigureOut">
              <a:rPr lang="fa-IR" smtClean="0"/>
              <a:t>02/02/1444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3BE6C-7CED-4FC2-8312-7161AF0BEE86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078221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25571-EC6A-4930-BA58-3890F7A8C3ED}" type="datetimeFigureOut">
              <a:rPr lang="fa-IR" smtClean="0"/>
              <a:t>02/02/1444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3BE6C-7CED-4FC2-8312-7161AF0BEE86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4036223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25571-EC6A-4930-BA58-3890F7A8C3ED}" type="datetimeFigureOut">
              <a:rPr lang="fa-IR" smtClean="0"/>
              <a:t>02/02/1444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3BE6C-7CED-4FC2-8312-7161AF0BEE86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440205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25571-EC6A-4930-BA58-3890F7A8C3ED}" type="datetimeFigureOut">
              <a:rPr lang="fa-IR" smtClean="0"/>
              <a:t>02/02/1444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3BE6C-7CED-4FC2-8312-7161AF0BEE86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967809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25571-EC6A-4930-BA58-3890F7A8C3ED}" type="datetimeFigureOut">
              <a:rPr lang="fa-IR" smtClean="0"/>
              <a:t>02/02/1444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3BE6C-7CED-4FC2-8312-7161AF0BEE86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4051564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25571-EC6A-4930-BA58-3890F7A8C3ED}" type="datetimeFigureOut">
              <a:rPr lang="fa-IR" smtClean="0"/>
              <a:t>02/02/1444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3BE6C-7CED-4FC2-8312-7161AF0BEE86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991303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25571-EC6A-4930-BA58-3890F7A8C3ED}" type="datetimeFigureOut">
              <a:rPr lang="fa-IR" smtClean="0"/>
              <a:t>02/02/1444</a:t>
            </a:fld>
            <a:endParaRPr lang="fa-I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3BE6C-7CED-4FC2-8312-7161AF0BEE86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4452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25571-EC6A-4930-BA58-3890F7A8C3ED}" type="datetimeFigureOut">
              <a:rPr lang="fa-IR" smtClean="0"/>
              <a:t>02/02/1444</a:t>
            </a:fld>
            <a:endParaRPr lang="fa-I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3BE6C-7CED-4FC2-8312-7161AF0BEE86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9207284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25571-EC6A-4930-BA58-3890F7A8C3ED}" type="datetimeFigureOut">
              <a:rPr lang="fa-IR" smtClean="0"/>
              <a:t>02/02/1444</a:t>
            </a:fld>
            <a:endParaRPr lang="fa-I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3BE6C-7CED-4FC2-8312-7161AF0BEE86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31421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25571-EC6A-4930-BA58-3890F7A8C3ED}" type="datetimeFigureOut">
              <a:rPr lang="fa-IR" smtClean="0"/>
              <a:t>02/02/1444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3BE6C-7CED-4FC2-8312-7161AF0BEE86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333619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25571-EC6A-4930-BA58-3890F7A8C3ED}" type="datetimeFigureOut">
              <a:rPr lang="fa-IR" smtClean="0"/>
              <a:t>02/02/1444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3BE6C-7CED-4FC2-8312-7161AF0BEE86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4010699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B25571-EC6A-4930-BA58-3890F7A8C3ED}" type="datetimeFigureOut">
              <a:rPr lang="fa-IR" smtClean="0"/>
              <a:t>02/02/1444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23BE6C-7CED-4FC2-8312-7161AF0BEE86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2748812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D75373C-A7A8-4EC9-A7E0-C4A43C0302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8063" y="3200046"/>
            <a:ext cx="4885852" cy="5071265"/>
          </a:xfrm>
          <a:prstGeom prst="rect">
            <a:avLst/>
          </a:prstGeom>
        </p:spPr>
      </p:pic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DB44ED6A-D13F-4F87-8121-4BD969FB0932}"/>
              </a:ext>
            </a:extLst>
          </p:cNvPr>
          <p:cNvGraphicFramePr>
            <a:graphicFrameLocks noGrp="1"/>
          </p:cNvGraphicFramePr>
          <p:nvPr/>
        </p:nvGraphicFramePr>
        <p:xfrm>
          <a:off x="443525" y="953784"/>
          <a:ext cx="4970390" cy="1794388"/>
        </p:xfrm>
        <a:graphic>
          <a:graphicData uri="http://schemas.openxmlformats.org/drawingml/2006/table">
            <a:tbl>
              <a:tblPr rtl="1" firstRow="1" bandRow="1">
                <a:tableStyleId>{5940675A-B579-460E-94D1-54222C63F5DA}</a:tableStyleId>
              </a:tblPr>
              <a:tblGrid>
                <a:gridCol w="4793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2131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21627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5348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33038">
                <a:tc>
                  <a:txBody>
                    <a:bodyPr/>
                    <a:lstStyle/>
                    <a:p>
                      <a:pPr algn="ctr" rtl="0"/>
                      <a:endParaRPr lang="fa-IR" sz="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/>
                      <a:r>
                        <a:rPr lang="en-US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DR</a:t>
                      </a:r>
                      <a:endParaRPr lang="fa-IR" sz="10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/>
                      <a:r>
                        <a:rPr lang="en-US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on </a:t>
                      </a:r>
                      <a:endParaRPr lang="fa-IR" sz="10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/>
                      <a:r>
                        <a:rPr lang="en-US" sz="11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hway </a:t>
                      </a:r>
                      <a:endParaRPr lang="fa-IR" sz="105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3827">
                <a:tc>
                  <a:txBody>
                    <a:bodyPr/>
                    <a:lstStyle/>
                    <a:p>
                      <a:pPr rtl="1"/>
                      <a:endParaRPr lang="fa-IR" sz="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3e-12</a:t>
                      </a:r>
                      <a:endParaRPr lang="fa-IR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AR signaling pathway</a:t>
                      </a:r>
                      <a:endParaRPr lang="fa-IR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1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u03320</a:t>
                      </a:r>
                      <a:endParaRPr lang="fa-IR" sz="105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3827">
                <a:tc>
                  <a:txBody>
                    <a:bodyPr/>
                    <a:lstStyle/>
                    <a:p>
                      <a:pPr rtl="1"/>
                      <a:endParaRPr lang="fa-IR" sz="40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9e-11</a:t>
                      </a:r>
                      <a:endParaRPr lang="fa-IR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bolic pathways</a:t>
                      </a:r>
                      <a:endParaRPr lang="fa-IR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1"/>
                      <a:r>
                        <a:rPr lang="en-US" sz="1100" b="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mu01100</a:t>
                      </a:r>
                      <a:endParaRPr lang="fa-IR" sz="1100" b="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83827">
                <a:tc>
                  <a:txBody>
                    <a:bodyPr/>
                    <a:lstStyle/>
                    <a:p>
                      <a:pPr rtl="1"/>
                      <a:endParaRPr lang="fa-IR" sz="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98</a:t>
                      </a:r>
                      <a:endParaRPr lang="fa-IR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ulin signaling pathway</a:t>
                      </a:r>
                      <a:endParaRPr lang="fa-IR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1"/>
                      <a:r>
                        <a:rPr lang="en-US" sz="1100" b="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mu04910</a:t>
                      </a:r>
                      <a:endParaRPr lang="fa-IR" sz="1100" b="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83827">
                <a:tc>
                  <a:txBody>
                    <a:bodyPr/>
                    <a:lstStyle/>
                    <a:p>
                      <a:pPr rtl="1"/>
                      <a:endParaRPr lang="fa-IR" sz="40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98</a:t>
                      </a:r>
                      <a:endParaRPr lang="fa-IR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/>
                      <a:r>
                        <a:rPr lang="en-US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olysis/Gluconeogenesis</a:t>
                      </a:r>
                      <a:endParaRPr lang="fa-IR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1"/>
                      <a:r>
                        <a:rPr lang="en-US" sz="1100" b="0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mu00010</a:t>
                      </a:r>
                      <a:endParaRPr lang="fa-IR" sz="1100" b="0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11" name="Oval 10">
            <a:extLst>
              <a:ext uri="{FF2B5EF4-FFF2-40B4-BE49-F238E27FC236}">
                <a16:creationId xmlns:a16="http://schemas.microsoft.com/office/drawing/2014/main" id="{E7959068-E234-4CDE-A548-9A4BBB71178A}"/>
              </a:ext>
            </a:extLst>
          </p:cNvPr>
          <p:cNvSpPr/>
          <p:nvPr/>
        </p:nvSpPr>
        <p:spPr>
          <a:xfrm>
            <a:off x="5064313" y="1346985"/>
            <a:ext cx="224719" cy="164833"/>
          </a:xfrm>
          <a:prstGeom prst="ellipse">
            <a:avLst/>
          </a:prstGeom>
          <a:solidFill>
            <a:srgbClr val="D8727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fa-IR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5135C691-481E-4CC2-A8AE-5346EFA8B03A}"/>
              </a:ext>
            </a:extLst>
          </p:cNvPr>
          <p:cNvSpPr/>
          <p:nvPr/>
        </p:nvSpPr>
        <p:spPr>
          <a:xfrm>
            <a:off x="5064312" y="1713633"/>
            <a:ext cx="224719" cy="164833"/>
          </a:xfrm>
          <a:prstGeom prst="ellipse">
            <a:avLst/>
          </a:prstGeom>
          <a:solidFill>
            <a:srgbClr val="6F6FD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fa-IR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4785F9CE-B702-4CF5-BDB6-ADB0EFC7BBA1}"/>
              </a:ext>
            </a:extLst>
          </p:cNvPr>
          <p:cNvSpPr/>
          <p:nvPr/>
        </p:nvSpPr>
        <p:spPr>
          <a:xfrm>
            <a:off x="5059383" y="2064935"/>
            <a:ext cx="224719" cy="164833"/>
          </a:xfrm>
          <a:prstGeom prst="ellipse">
            <a:avLst/>
          </a:prstGeom>
          <a:solidFill>
            <a:srgbClr val="8ECC8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fa-IR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805CFE87-F295-4E23-A9C9-92EE108418C7}"/>
              </a:ext>
            </a:extLst>
          </p:cNvPr>
          <p:cNvSpPr/>
          <p:nvPr/>
        </p:nvSpPr>
        <p:spPr>
          <a:xfrm>
            <a:off x="5064312" y="2473482"/>
            <a:ext cx="224719" cy="164833"/>
          </a:xfrm>
          <a:prstGeom prst="ellipse">
            <a:avLst/>
          </a:prstGeom>
          <a:solidFill>
            <a:srgbClr val="D1D16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fa-IR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9C1AF19-2471-4C74-BEA4-B637DA3111DA}"/>
              </a:ext>
            </a:extLst>
          </p:cNvPr>
          <p:cNvSpPr txBox="1"/>
          <p:nvPr/>
        </p:nvSpPr>
        <p:spPr>
          <a:xfrm>
            <a:off x="392725" y="298716"/>
            <a:ext cx="370615" cy="46166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2400" b="1" dirty="0"/>
              <a:t>A</a:t>
            </a:r>
            <a:endParaRPr lang="fa-IR" sz="24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A4F0828-7CFE-43A1-B3A8-DB6641D5D36A}"/>
              </a:ext>
            </a:extLst>
          </p:cNvPr>
          <p:cNvSpPr txBox="1"/>
          <p:nvPr/>
        </p:nvSpPr>
        <p:spPr>
          <a:xfrm>
            <a:off x="392724" y="2969213"/>
            <a:ext cx="370615" cy="46166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2400" b="1" dirty="0"/>
              <a:t>B</a:t>
            </a:r>
            <a:endParaRPr lang="fa-IR" sz="2400" b="1" dirty="0"/>
          </a:p>
        </p:txBody>
      </p:sp>
    </p:spTree>
    <p:extLst>
      <p:ext uri="{BB962C8B-B14F-4D97-AF65-F5344CB8AC3E}">
        <p14:creationId xmlns:p14="http://schemas.microsoft.com/office/powerpoint/2010/main" val="13365676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7</TotalTime>
  <Words>24</Words>
  <Application>Microsoft Office PowerPoint</Application>
  <PresentationFormat>A4 Paper (210x297 mm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ar User</dc:creator>
  <cp:lastModifiedBy>Dena</cp:lastModifiedBy>
  <cp:revision>61</cp:revision>
  <dcterms:created xsi:type="dcterms:W3CDTF">2020-03-27T08:09:11Z</dcterms:created>
  <dcterms:modified xsi:type="dcterms:W3CDTF">2022-08-29T07:21:55Z</dcterms:modified>
</cp:coreProperties>
</file>